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1E0EF-304D-49FC-9D14-04D117DB6E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F0D9E6-855A-4896-BA2C-5E236BA8CF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A496B-9788-4406-8066-ADDAFB0532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0BD1F-4232-43EF-AAFC-000BCC3D45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7AB73-C1F2-4D6A-8FA3-FCE3986770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B00F5-DB9D-4C3C-A1A4-A3F3A06E42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9EDEA-3358-4D79-9C08-AC9DC35853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F16A1-FBCE-4131-AA7E-213C402D73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90B56-1272-4734-8748-E0F61FA57A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400AB0-179A-4DB8-80C5-E3AE4DE1F0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205D4-F27A-47D4-8089-38C77D2FC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DEDD4-1E02-46A0-874F-6876D5EE87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1810F3-6923-48EB-B821-BECD454D2E81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73160" y="1136520"/>
            <a:ext cx="8791560" cy="48848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79280" y="18900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iological Proc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S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996840" y="871560"/>
            <a:ext cx="7320240" cy="57974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79280" y="18900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lecular Fun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S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1187280" y="438120"/>
            <a:ext cx="7450200" cy="61596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79280" y="26028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ellular Compon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S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3T14:36:07Z</dcterms:created>
  <dc:creator>Customer</dc:creator>
  <dc:description/>
  <dc:language>en-US</dc:language>
  <cp:lastModifiedBy>Customer</cp:lastModifiedBy>
  <dcterms:modified xsi:type="dcterms:W3CDTF">2012-10-23T14:19:18Z</dcterms:modified>
  <cp:revision>2</cp:revision>
  <dc:subject/>
  <dc:title>Slide 1</dc:title>
</cp:coreProperties>
</file>